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6858000" cy="9144000" type="screen4x3"/>
  <p:notesSz cx="6811963" cy="99456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1038" y="-15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37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532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2494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4378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425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37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8314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0247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9629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7480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1668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F336-4BE8-4F20-936E-C8CE888C53F6}" type="datetimeFigureOut">
              <a:rPr lang="fr-FR" smtClean="0"/>
              <a:t>01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C6345-C6F4-4549-9443-E5BA0EF91F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000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268760" y="611560"/>
            <a:ext cx="4680520" cy="2736304"/>
            <a:chOff x="1268760" y="611560"/>
            <a:chExt cx="4680520" cy="2736304"/>
          </a:xfrm>
        </p:grpSpPr>
        <p:sp>
          <p:nvSpPr>
            <p:cNvPr id="3" name="Rectangle 2"/>
            <p:cNvSpPr/>
            <p:nvPr/>
          </p:nvSpPr>
          <p:spPr>
            <a:xfrm>
              <a:off x="1268760" y="611560"/>
              <a:ext cx="4680520" cy="27363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" name="Groupe 1"/>
            <p:cNvGrpSpPr/>
            <p:nvPr/>
          </p:nvGrpSpPr>
          <p:grpSpPr>
            <a:xfrm>
              <a:off x="1340768" y="683568"/>
              <a:ext cx="4464496" cy="2544960"/>
              <a:chOff x="1340768" y="683568"/>
              <a:chExt cx="4464496" cy="2544960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1340768" y="683568"/>
                <a:ext cx="4464496" cy="21602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grpSp>
            <p:nvGrpSpPr>
              <p:cNvPr id="28" name="Groupe 27"/>
              <p:cNvGrpSpPr>
                <a:grpSpLocks/>
              </p:cNvGrpSpPr>
              <p:nvPr/>
            </p:nvGrpSpPr>
            <p:grpSpPr bwMode="auto">
              <a:xfrm>
                <a:off x="2053518" y="1185729"/>
                <a:ext cx="3409768" cy="1139294"/>
                <a:chOff x="1097659" y="1326675"/>
                <a:chExt cx="7152216" cy="2660119"/>
              </a:xfrm>
            </p:grpSpPr>
            <p:pic>
              <p:nvPicPr>
                <p:cNvPr id="29" name="Picture 106" descr="3++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 l="9439" t="16765" r="9723" b="10629"/>
                <a:stretch>
                  <a:fillRect/>
                </a:stretch>
              </p:blipFill>
              <p:spPr bwMode="auto">
                <a:xfrm rot="5400000" flipV="1">
                  <a:off x="4517396" y="1830665"/>
                  <a:ext cx="1899820" cy="99807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0" name="Picture 150" descr="Plantes 2b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56155" t="41492" r="19858" b="37424"/>
                <a:stretch>
                  <a:fillRect/>
                </a:stretch>
              </p:blipFill>
              <p:spPr bwMode="auto">
                <a:xfrm rot="5400000" flipV="1">
                  <a:off x="631311" y="1793023"/>
                  <a:ext cx="1938954" cy="100625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1" name="Picture 123" descr="Plante J2 024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 l="60609" t="34875" r="19023" b="48407"/>
                <a:stretch>
                  <a:fillRect/>
                </a:stretch>
              </p:blipFill>
              <p:spPr bwMode="auto">
                <a:xfrm rot="5400000" flipV="1">
                  <a:off x="5746894" y="1883751"/>
                  <a:ext cx="1936609" cy="9286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2" name="Picture 154" descr="Plantes J6 037PS3"/>
                <p:cNvPicPr>
                  <a:picLocks noChangeAspect="1" noChangeArrowheads="1"/>
                </p:cNvPicPr>
                <p:nvPr/>
              </p:nvPicPr>
              <p:blipFill>
                <a:blip r:embed="rId5">
                  <a:lum bright="6000"/>
                </a:blip>
                <a:srcRect l="10088" t="30502" r="11179" b="15944"/>
                <a:stretch>
                  <a:fillRect/>
                </a:stretch>
              </p:blipFill>
              <p:spPr bwMode="auto">
                <a:xfrm rot="5400000" flipV="1">
                  <a:off x="6865385" y="1955970"/>
                  <a:ext cx="1983162" cy="785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3" name="Picture 103" descr="1"/>
                <p:cNvPicPr>
                  <a:picLocks noChangeAspect="1" noChangeArrowheads="1"/>
                </p:cNvPicPr>
                <p:nvPr/>
              </p:nvPicPr>
              <p:blipFill>
                <a:blip r:embed="rId6"/>
                <a:srcRect l="13371" t="11676" r="5057" b="20360"/>
                <a:stretch>
                  <a:fillRect/>
                </a:stretch>
              </p:blipFill>
              <p:spPr bwMode="auto">
                <a:xfrm rot="5400000" flipV="1">
                  <a:off x="3264174" y="1868394"/>
                  <a:ext cx="1908184" cy="93098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4" name="Picture 5"/>
                <p:cNvPicPr preferRelativeResize="0">
                  <a:picLocks noChangeAspect="1" noChangeArrowheads="1"/>
                </p:cNvPicPr>
                <p:nvPr/>
              </p:nvPicPr>
              <p:blipFill>
                <a:blip r:embed="rId7"/>
                <a:srcRect l="9523" r="23828" b="17480"/>
                <a:stretch>
                  <a:fillRect/>
                </a:stretch>
              </p:blipFill>
              <p:spPr bwMode="auto">
                <a:xfrm rot="16200000" flipV="1">
                  <a:off x="1963932" y="1804290"/>
                  <a:ext cx="1928826" cy="1079838"/>
                </a:xfrm>
                <a:prstGeom prst="rect">
                  <a:avLst/>
                </a:prstGeom>
                <a:noFill/>
                <a:ln w="19050">
                  <a:noFill/>
                  <a:miter lim="800000"/>
                  <a:headEnd/>
                  <a:tailEnd/>
                </a:ln>
              </p:spPr>
            </p:pic>
            <p:sp>
              <p:nvSpPr>
                <p:cNvPr id="35" name="ZoneTexte 9"/>
                <p:cNvSpPr txBox="1">
                  <a:spLocks noChangeArrowheads="1"/>
                </p:cNvSpPr>
                <p:nvPr/>
              </p:nvSpPr>
              <p:spPr bwMode="auto">
                <a:xfrm>
                  <a:off x="1339586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ZoneTexte 10"/>
                <p:cNvSpPr txBox="1">
                  <a:spLocks noChangeArrowheads="1"/>
                </p:cNvSpPr>
                <p:nvPr/>
              </p:nvSpPr>
              <p:spPr bwMode="auto">
                <a:xfrm>
                  <a:off x="2550193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ZoneTexte 11"/>
                <p:cNvSpPr txBox="1">
                  <a:spLocks noChangeArrowheads="1"/>
                </p:cNvSpPr>
                <p:nvPr/>
              </p:nvSpPr>
              <p:spPr bwMode="auto">
                <a:xfrm>
                  <a:off x="3760799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ZoneTexte 12"/>
                <p:cNvSpPr txBox="1">
                  <a:spLocks noChangeArrowheads="1"/>
                </p:cNvSpPr>
                <p:nvPr/>
              </p:nvSpPr>
              <p:spPr bwMode="auto">
                <a:xfrm>
                  <a:off x="4971405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ZoneTexte 13"/>
                <p:cNvSpPr txBox="1">
                  <a:spLocks noChangeArrowheads="1"/>
                </p:cNvSpPr>
                <p:nvPr/>
              </p:nvSpPr>
              <p:spPr bwMode="auto">
                <a:xfrm>
                  <a:off x="6182012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ZoneTexte 14"/>
                <p:cNvSpPr txBox="1">
                  <a:spLocks noChangeArrowheads="1"/>
                </p:cNvSpPr>
                <p:nvPr/>
              </p:nvSpPr>
              <p:spPr bwMode="auto">
                <a:xfrm>
                  <a:off x="7392620" y="3411897"/>
                  <a:ext cx="535295" cy="5748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ZoneTexte 5"/>
              <p:cNvSpPr txBox="1"/>
              <p:nvPr/>
            </p:nvSpPr>
            <p:spPr>
              <a:xfrm>
                <a:off x="1992005" y="2459087"/>
                <a:ext cx="3813259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</a:t>
                </a:r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igure 1 </a:t>
                </a:r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mptom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verity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dex.</a:t>
                </a:r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ctures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resentatives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ch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the scores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om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 to 5 of the 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mptom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verity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dex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ter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oulation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</a:t>
                </a:r>
                <a:r>
                  <a:rPr lang="fr-FR" sz="11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 thaliana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ves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ith</a:t>
                </a:r>
                <a:r>
                  <a:rPr lang="fr-FR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1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. </a:t>
                </a:r>
                <a:r>
                  <a:rPr lang="fr-FR" sz="11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dantii</a:t>
                </a:r>
                <a:r>
                  <a:rPr lang="fr-FR" sz="11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endParaRPr lang="fr-FR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87068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58</TotalTime>
  <Words>42</Words>
  <Application>Microsoft Office PowerPoint</Application>
  <PresentationFormat>Affichage à l'écra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</dc:creator>
  <cp:lastModifiedBy>Alia Dellagi</cp:lastModifiedBy>
  <cp:revision>165</cp:revision>
  <cp:lastPrinted>2016-12-04T09:20:56Z</cp:lastPrinted>
  <dcterms:created xsi:type="dcterms:W3CDTF">2016-07-18T16:37:55Z</dcterms:created>
  <dcterms:modified xsi:type="dcterms:W3CDTF">2021-02-01T15:02:24Z</dcterms:modified>
</cp:coreProperties>
</file>